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6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2400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BBC90-D260-46B5-B5EE-9DF85B919C6B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CD889-9438-4A2C-8801-92175A744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33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BBC90-D260-46B5-B5EE-9DF85B919C6B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CD889-9438-4A2C-8801-92175A744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286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BBC90-D260-46B5-B5EE-9DF85B919C6B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CD889-9438-4A2C-8801-92175A744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061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BBC90-D260-46B5-B5EE-9DF85B919C6B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CD889-9438-4A2C-8801-92175A744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7172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BBC90-D260-46B5-B5EE-9DF85B919C6B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CD889-9438-4A2C-8801-92175A744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2779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BBC90-D260-46B5-B5EE-9DF85B919C6B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CD889-9438-4A2C-8801-92175A744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944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BBC90-D260-46B5-B5EE-9DF85B919C6B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CD889-9438-4A2C-8801-92175A744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5403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BBC90-D260-46B5-B5EE-9DF85B919C6B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CD889-9438-4A2C-8801-92175A744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568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BBC90-D260-46B5-B5EE-9DF85B919C6B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CD889-9438-4A2C-8801-92175A744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931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BBC90-D260-46B5-B5EE-9DF85B919C6B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CD889-9438-4A2C-8801-92175A744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4345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BBC90-D260-46B5-B5EE-9DF85B919C6B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CD889-9438-4A2C-8801-92175A744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253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EBBC90-D260-46B5-B5EE-9DF85B919C6B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DCD889-9438-4A2C-8801-92175A744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841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62" r="807"/>
          <a:stretch/>
        </p:blipFill>
        <p:spPr>
          <a:xfrm>
            <a:off x="3565471" y="869533"/>
            <a:ext cx="2419695" cy="243497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3918" y="3367723"/>
            <a:ext cx="2420112" cy="2432304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8944" y="3373368"/>
            <a:ext cx="2420112" cy="242011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75" t="32823" r="30372" b="31643"/>
          <a:stretch/>
        </p:blipFill>
        <p:spPr>
          <a:xfrm>
            <a:off x="985894" y="853481"/>
            <a:ext cx="2404004" cy="243693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08529" y="907676"/>
            <a:ext cx="38660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546662" y="907676"/>
            <a:ext cx="31936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857250" y="6110639"/>
            <a:ext cx="5093064" cy="7443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059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ell lines, fly lines, and antibodies. (A) Karyotype of ML82-19a cell line stained with anti-phospho-H3S10. (B) </a:t>
            </a:r>
            <a:r>
              <a:rPr lang="en-US" sz="1059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[Cid-GFP]8-10 </a:t>
            </a:r>
            <a:r>
              <a:rPr lang="en-US" sz="1059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ined with anti-GFP antibody. (C, D) Anti-</a:t>
            </a:r>
            <a:r>
              <a:rPr lang="en-US" sz="105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dM</a:t>
            </a:r>
            <a:r>
              <a:rPr lang="en-US" sz="105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9">
                <a:latin typeface="Times New Roman" panose="02020603050405020304" pitchFamily="18" charset="0"/>
                <a:cs typeface="Times New Roman" panose="02020603050405020304" pitchFamily="18" charset="0"/>
              </a:rPr>
              <a:t>staining of (C) </a:t>
            </a:r>
            <a:r>
              <a:rPr lang="en-US" sz="1059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cells and (D) ML82-19a cells.</a:t>
            </a:r>
          </a:p>
          <a:p>
            <a:endParaRPr lang="en-US" sz="1059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82804" y="3387633"/>
            <a:ext cx="38660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547864" y="3387634"/>
            <a:ext cx="386603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82" b="1" dirty="0">
                <a:solidFill>
                  <a:schemeClr val="bg1"/>
                </a:solidFill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706004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</TotalTime>
  <Words>57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Fred Hut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lbert, Paul</dc:creator>
  <cp:lastModifiedBy>Talbert, Paul</cp:lastModifiedBy>
  <cp:revision>5</cp:revision>
  <dcterms:created xsi:type="dcterms:W3CDTF">2017-09-25T22:34:26Z</dcterms:created>
  <dcterms:modified xsi:type="dcterms:W3CDTF">2017-12-08T20:44:07Z</dcterms:modified>
</cp:coreProperties>
</file>